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69" r:id="rId1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-2560" y="-10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8546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0226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5440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2545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0192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5464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4815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5893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5275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4925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5402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11BA1-FF59-4818-8051-73920ED43A27}" type="datetimeFigureOut">
              <a:rPr lang="en-AU" smtClean="0"/>
              <a:t>6/12/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449FC5-E7CD-4051-A9FD-0D990BBC89C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65649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15257" y="3826782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ciaR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857" y="4315631"/>
            <a:ext cx="6267231" cy="398713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68294" y="457200"/>
            <a:ext cx="636179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S1 </a:t>
            </a:r>
            <a:r>
              <a:rPr lang="en-AU" dirty="0" smtClean="0"/>
              <a:t>Fig: </a:t>
            </a:r>
            <a:r>
              <a:rPr lang="en-AU" dirty="0"/>
              <a:t>Maximum likelihood phylogenetic </a:t>
            </a:r>
            <a:r>
              <a:rPr lang="en-AU" dirty="0" smtClean="0"/>
              <a:t>trees </a:t>
            </a:r>
            <a:r>
              <a:rPr lang="en-AU" dirty="0"/>
              <a:t>of the intergenic region upstream of the GAS TCS based on Muscle alignment and 40% bootstrap annotated with intergenic allele number (I prefix), </a:t>
            </a:r>
            <a:r>
              <a:rPr lang="en-AU" i="1" dirty="0" err="1"/>
              <a:t>emm</a:t>
            </a:r>
            <a:r>
              <a:rPr lang="en-AU" dirty="0"/>
              <a:t>-cluster, and disease. Legend: </a:t>
            </a:r>
            <a:r>
              <a:rPr lang="en-AU" dirty="0" smtClean="0"/>
              <a:t>ARF=Acute Rheumatic Fever, </a:t>
            </a:r>
            <a:r>
              <a:rPr lang="en-AU" dirty="0"/>
              <a:t>PSGN=Post streptococcal glomerulonephritis, SF= Scarlet fever, PH= Pharyngitis, COM= Community (asymptomatic), O=Other, U=Unknown</a:t>
            </a:r>
            <a:r>
              <a:rPr lang="en-AU" dirty="0" smtClean="0"/>
              <a:t>. </a:t>
            </a:r>
            <a:r>
              <a:rPr lang="en-AU" i="1" dirty="0" err="1" smtClean="0"/>
              <a:t>Emm</a:t>
            </a:r>
            <a:r>
              <a:rPr lang="en-AU" dirty="0" smtClean="0"/>
              <a:t>-type and </a:t>
            </a:r>
            <a:r>
              <a:rPr lang="en-AU" i="1" dirty="0" err="1" smtClean="0"/>
              <a:t>emm</a:t>
            </a:r>
            <a:r>
              <a:rPr lang="en-AU" dirty="0" smtClean="0"/>
              <a:t>-pattern of isolates possessing the allele are annotated. </a:t>
            </a:r>
            <a:endParaRPr lang="en-AU" dirty="0"/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5348443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trxT</a:t>
            </a:r>
            <a:endParaRPr lang="en-AU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341" y="1345881"/>
            <a:ext cx="5590517" cy="4413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52222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vicR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857" y="758367"/>
            <a:ext cx="5919729" cy="47126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2438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covR</a:t>
            </a:r>
            <a:endParaRPr lang="en-AU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429" y="1673934"/>
            <a:ext cx="5986791" cy="4157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7180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fasB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944" y="1255568"/>
            <a:ext cx="5334462" cy="4804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1991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irr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857" y="833789"/>
            <a:ext cx="6090432" cy="4767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54108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841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err="1" smtClean="0"/>
              <a:t>IliaF</a:t>
            </a:r>
            <a:endParaRPr lang="en-AU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903" y="969884"/>
            <a:ext cx="5895343" cy="3279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74455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Ispy0873</a:t>
            </a:r>
            <a:endParaRPr lang="en-AU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094" y="1052389"/>
            <a:ext cx="5249111" cy="7248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61587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9297" y="515230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Ispy1061</a:t>
            </a:r>
            <a:endParaRPr lang="en-AU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297" y="1197651"/>
            <a:ext cx="6450127" cy="4919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74146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Ispy1107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332" y="1029669"/>
            <a:ext cx="6261135" cy="4017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52949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62857" y="464457"/>
            <a:ext cx="1161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 smtClean="0"/>
              <a:t>Ispy1556</a:t>
            </a:r>
            <a:endParaRPr lang="en-AU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41" y="1624001"/>
            <a:ext cx="6468417" cy="4657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1602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8</TotalTime>
  <Words>105</Words>
  <Application>Microsoft Macintosh PowerPoint</Application>
  <PresentationFormat>Custom</PresentationFormat>
  <Paragraphs>12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the Sunshine Coa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an Buckley</dc:creator>
  <cp:lastModifiedBy>David Knight</cp:lastModifiedBy>
  <cp:revision>32</cp:revision>
  <dcterms:created xsi:type="dcterms:W3CDTF">2018-02-13T03:46:44Z</dcterms:created>
  <dcterms:modified xsi:type="dcterms:W3CDTF">2018-06-12T18:33:52Z</dcterms:modified>
</cp:coreProperties>
</file>